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handoutMasterIdLst>
    <p:handoutMasterId r:id="rId15"/>
  </p:handoutMasterIdLst>
  <p:sldIdLst>
    <p:sldId id="338" r:id="rId2"/>
    <p:sldId id="340" r:id="rId3"/>
    <p:sldId id="335" r:id="rId4"/>
    <p:sldId id="336" r:id="rId5"/>
    <p:sldId id="337" r:id="rId6"/>
    <p:sldId id="331" r:id="rId7"/>
    <p:sldId id="334" r:id="rId8"/>
    <p:sldId id="320" r:id="rId9"/>
    <p:sldId id="321" r:id="rId10"/>
    <p:sldId id="322" r:id="rId11"/>
    <p:sldId id="323" r:id="rId12"/>
    <p:sldId id="332" r:id="rId13"/>
  </p:sldIdLst>
  <p:sldSz cx="9144000" cy="6858000" type="screen4x3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0391" autoAdjust="0"/>
  </p:normalViewPr>
  <p:slideViewPr>
    <p:cSldViewPr>
      <p:cViewPr varScale="1">
        <p:scale>
          <a:sx n="96" d="100"/>
          <a:sy n="96" d="100"/>
        </p:scale>
        <p:origin x="1956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73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29282" cy="350760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014" y="0"/>
            <a:ext cx="4029282" cy="350760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E870F61D-E74A-4881-A133-211A0BC10EB9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658443"/>
            <a:ext cx="4029282" cy="35076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014" y="6658443"/>
            <a:ext cx="4029282" cy="35076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26E51BF8-7F37-43DA-9504-419D47A42D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26404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8440" cy="350520"/>
          </a:xfrm>
          <a:prstGeom prst="rect">
            <a:avLst/>
          </a:prstGeom>
        </p:spPr>
        <p:txBody>
          <a:bodyPr vert="horz" lIns="93164" tIns="46582" rIns="93164" bIns="4658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809" y="0"/>
            <a:ext cx="4028440" cy="350520"/>
          </a:xfrm>
          <a:prstGeom prst="rect">
            <a:avLst/>
          </a:prstGeom>
        </p:spPr>
        <p:txBody>
          <a:bodyPr vert="horz" lIns="93164" tIns="46582" rIns="93164" bIns="46582" rtlCol="0"/>
          <a:lstStyle>
            <a:lvl1pPr algn="r">
              <a:defRPr sz="1200"/>
            </a:lvl1pPr>
          </a:lstStyle>
          <a:p>
            <a:fld id="{DB418BC3-C53E-42CC-87AC-B9EE5A720768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95600" y="525463"/>
            <a:ext cx="3505200" cy="2628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4" tIns="46582" rIns="93164" bIns="4658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9640" y="3329940"/>
            <a:ext cx="7437120" cy="3154680"/>
          </a:xfrm>
          <a:prstGeom prst="rect">
            <a:avLst/>
          </a:prstGeom>
        </p:spPr>
        <p:txBody>
          <a:bodyPr vert="horz" lIns="93164" tIns="46582" rIns="93164" bIns="4658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58664"/>
            <a:ext cx="4028440" cy="350520"/>
          </a:xfrm>
          <a:prstGeom prst="rect">
            <a:avLst/>
          </a:prstGeom>
        </p:spPr>
        <p:txBody>
          <a:bodyPr vert="horz" lIns="93164" tIns="46582" rIns="93164" bIns="4658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809" y="6658664"/>
            <a:ext cx="4028440" cy="350520"/>
          </a:xfrm>
          <a:prstGeom prst="rect">
            <a:avLst/>
          </a:prstGeom>
        </p:spPr>
        <p:txBody>
          <a:bodyPr vert="horz" lIns="93164" tIns="46582" rIns="93164" bIns="46582" rtlCol="0" anchor="b"/>
          <a:lstStyle>
            <a:lvl1pPr algn="r">
              <a:defRPr sz="1200"/>
            </a:lvl1pPr>
          </a:lstStyle>
          <a:p>
            <a:fld id="{D3C32223-C04D-406C-854F-3ECCF2633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7346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90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710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793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340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050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869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996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234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218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7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532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B7AF3-D8DF-4047-AC2C-EB4B21D91E6A}" type="datetimeFigureOut">
              <a:rPr lang="en-US" smtClean="0"/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580A0-9F72-46C7-B13C-2EC3B9642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819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6935411"/>
              </p:ext>
            </p:extLst>
          </p:nvPr>
        </p:nvGraphicFramePr>
        <p:xfrm>
          <a:off x="1066801" y="838200"/>
          <a:ext cx="7080250" cy="22676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387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543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8526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7742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5920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652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533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truc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cotyledon explant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purple spo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le spot formation rate 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R efficiency</a:t>
                      </a:r>
                      <a:r>
                        <a:rPr lang="en-US" sz="14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r>
                        <a:rPr lang="en-US" sz="1400" b="1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68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T1ox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3.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68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C2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5 ± 0.4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68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R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6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1 ± 0.6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468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p</a:t>
                      </a:r>
                      <a:r>
                        <a:rPr lang="en-US" sz="14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3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 ± 0.4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468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RNA</a:t>
                      </a:r>
                      <a:r>
                        <a:rPr lang="en-US" sz="14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 ± 0.4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914400" y="304800"/>
            <a:ext cx="73914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1A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urple spot data collected in the experiment for compariso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f HDR efficiency between different constructs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4468648"/>
              </p:ext>
            </p:extLst>
          </p:nvPr>
        </p:nvGraphicFramePr>
        <p:xfrm>
          <a:off x="533400" y="4028420"/>
          <a:ext cx="8077200" cy="244221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3694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9885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2356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4828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235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7206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42538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truc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toperiod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cotyledon explant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purple spo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le spot formation rate 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R efficiency</a:t>
                      </a:r>
                      <a:r>
                        <a:rPr lang="en-US" sz="14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r>
                        <a:rPr lang="en-US" sz="1400" b="1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T1ox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2.8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L/16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81.4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L/8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3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6.6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C2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4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6 ± 0.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L/16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7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9 ± 0.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L/8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3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7 ± 0.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R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4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0 ± 0.9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L/16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.0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6 ± 1.2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L/8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.6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2 ± 1.2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755650" y="3505200"/>
            <a:ext cx="73914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1B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urple spot data collected in the experiment for assessment o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mpact of photoperiod on HDR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66800" y="3200400"/>
            <a:ext cx="970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 smtClean="0"/>
              <a:t>*</a:t>
            </a:r>
            <a:r>
              <a:rPr lang="en-US" baseline="30000" dirty="0" err="1" smtClean="0"/>
              <a:t>mean±SEM</a:t>
            </a:r>
            <a:endParaRPr lang="en-US" baseline="30000" dirty="0"/>
          </a:p>
        </p:txBody>
      </p:sp>
      <p:sp>
        <p:nvSpPr>
          <p:cNvPr id="7" name="TextBox 6"/>
          <p:cNvSpPr txBox="1"/>
          <p:nvPr/>
        </p:nvSpPr>
        <p:spPr>
          <a:xfrm>
            <a:off x="581731" y="6477000"/>
            <a:ext cx="970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 smtClean="0"/>
              <a:t>*</a:t>
            </a:r>
            <a:r>
              <a:rPr lang="en-US" baseline="30000" dirty="0" err="1" smtClean="0"/>
              <a:t>mean±SEM</a:t>
            </a:r>
            <a:endParaRPr lang="en-US" baseline="30000" dirty="0"/>
          </a:p>
        </p:txBody>
      </p:sp>
    </p:spTree>
    <p:extLst>
      <p:ext uri="{BB962C8B-B14F-4D97-AF65-F5344CB8AC3E}">
        <p14:creationId xmlns:p14="http://schemas.microsoft.com/office/powerpoint/2010/main" val="23281248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363792" y="640376"/>
            <a:ext cx="83820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en-US" sz="14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8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henotypic segregation of self-pollinated offspring resulting from LbCpf1-based HDR events.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9073452"/>
              </p:ext>
            </p:extLst>
          </p:nvPr>
        </p:nvGraphicFramePr>
        <p:xfrm>
          <a:off x="457200" y="1134277"/>
          <a:ext cx="8153400" cy="41727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500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770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7700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7700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1452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7700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7292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7700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3083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9629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0 event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GE1 plants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rk purple plan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HDR</a:t>
                      </a:r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r>
                        <a:rPr lang="en-US" sz="1400" b="1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ght purple plants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HDR</a:t>
                      </a:r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r>
                        <a:rPr lang="en-US" sz="1400" b="1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lik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.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eaLnBrk="0" fontAlgn="ctr" hangingPunct="0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.6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7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7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eaLnBrk="0" fontAlgn="ctr" hangingPunct="0"/>
                      <a:r>
                        <a:rPr lang="en-US" sz="14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7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.9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eaLnBrk="0" fontAlgn="ctr" hangingPunct="0"/>
                      <a:r>
                        <a:rPr lang="en-US" sz="1400" u="none" strike="noStrike" dirty="0" smtClean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.10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400" u="none" strike="noStrike" dirty="0" smtClean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eaLnBrk="0" fontAlgn="ctr" hangingPunct="0"/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400" u="none" strike="noStrike" dirty="0" smtClean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.11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0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0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eaLnBrk="0" fontAlgn="ctr" hangingPunct="0"/>
                      <a:r>
                        <a:rPr lang="en-US" sz="14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.1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eaLnBrk="0" fontAlgn="ctr" hangingPunct="0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.14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14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eaLnBrk="0" fontAlgn="ctr" hangingPunct="0"/>
                      <a:r>
                        <a:rPr lang="en-US" sz="1400" u="none" strike="noStrike" dirty="0" smtClean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rgbClr val="7030A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14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4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.15</a:t>
                      </a:r>
                      <a:endParaRPr lang="en-US" sz="14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0</a:t>
                      </a:r>
                      <a:endParaRPr lang="en-US" sz="14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14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eaLnBrk="0" fontAlgn="ctr" hangingPunct="0"/>
                      <a:r>
                        <a:rPr lang="en-US" sz="140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0</a:t>
                      </a:r>
                      <a:endParaRPr lang="en-US" sz="140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.16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9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6</a:t>
                      </a:r>
                      <a:endParaRPr lang="en-US" sz="14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eaLnBrk="0" fontAlgn="ctr" hangingPunct="0"/>
                      <a:r>
                        <a:rPr lang="en-US" sz="14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6</a:t>
                      </a:r>
                      <a:endParaRPr lang="en-US" sz="14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20984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m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800" b="0" i="0" u="none" strike="noStrike" dirty="0">
                        <a:solidFill>
                          <a:srgbClr val="7030A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533400" y="5334000"/>
            <a:ext cx="8077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rk purple or homozygous-like HDR plants</a:t>
            </a:r>
          </a:p>
          <a:p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ght purp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eterozygous-lik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D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nts</a:t>
            </a:r>
            <a:endParaRPr lang="en-US" sz="1200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172132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685800" y="1505634"/>
            <a:ext cx="76962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9</a:t>
            </a:r>
            <a:r>
              <a:rPr lang="en-US" altLang="en-US" sz="14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mmary of the SlHKT1;2 HDR experiment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8999369"/>
              </p:ext>
            </p:extLst>
          </p:nvPr>
        </p:nvGraphicFramePr>
        <p:xfrm>
          <a:off x="685800" y="1828800"/>
          <a:ext cx="7696199" cy="1315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770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6769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6769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6769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6769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6769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umber of</a:t>
                      </a:r>
                      <a:r>
                        <a:rPr lang="en-US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eeds ( at 70% germination rate)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cotyledon fragm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analyzed</a:t>
                      </a:r>
                      <a:r>
                        <a:rPr lang="en-US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vents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Potential</a:t>
                      </a:r>
                      <a:r>
                        <a:rPr lang="en-US" sz="14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DR events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true HDR events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R efficiency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0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0</a:t>
                      </a:r>
                      <a:r>
                        <a:rPr lang="en-US" sz="1400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9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1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%**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685800" y="3124200"/>
            <a:ext cx="76962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an be done in only one transformation.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HKT1;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 donor templat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ain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ither antibiotic selection marker nor ANT1 colo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rker. 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40274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" y="76200"/>
            <a:ext cx="89916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en-US" sz="14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10.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Inde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utation rates among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KT1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amples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composed by ICE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ynthego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softwar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1231546"/>
              </p:ext>
            </p:extLst>
          </p:nvPr>
        </p:nvGraphicFramePr>
        <p:xfrm>
          <a:off x="381000" y="415499"/>
          <a:ext cx="8458199" cy="6137701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55036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797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1797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1968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7649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75773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31797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333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formed ev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tation rate (%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A1 </a:t>
                      </a:r>
                      <a:r>
                        <a:rPr lang="en-US" sz="11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A2 </a:t>
                      </a:r>
                      <a:r>
                        <a:rPr lang="en-US" sz="11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A1+gRNA2 </a:t>
                      </a:r>
                      <a:r>
                        <a:rPr lang="en-US" sz="11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ock-out rate (%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5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6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7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7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9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9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7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7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77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22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7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22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8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7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8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8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22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8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8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9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6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9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9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97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9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97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7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10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7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10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109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99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11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8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9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4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7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322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11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9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8809" marR="8809" marT="880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35559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r>
                        <a:rPr lang="en-US" sz="1100" b="1" kern="12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tation rat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8.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9.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4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87996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7783629"/>
              </p:ext>
            </p:extLst>
          </p:nvPr>
        </p:nvGraphicFramePr>
        <p:xfrm>
          <a:off x="685800" y="1918335"/>
          <a:ext cx="7772401" cy="311086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3260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55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5336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1461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9207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9207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39207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No.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emperature (oC)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Construct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otal cotyledon explant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otal number of purple spot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Purple spot formation rate 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DR efficiency (%)</a:t>
                      </a:r>
                      <a:r>
                        <a:rPr lang="en-US" sz="1400" b="1" u="none" strike="noStrike" kern="1200" baseline="300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*</a:t>
                      </a:r>
                      <a:endParaRPr lang="en-US" sz="1400" b="1" u="none" strike="noStrike" kern="1200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pANT1ox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06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630.7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TC2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8.9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 ± 0.2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HR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8.4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0 ± 0.3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2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ANT1ox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77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405.4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TC2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3.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9 ± 0.2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HR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41.9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8 ± 0.3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2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ANT1ox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79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283.8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TC2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6.0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8 ± 0.4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HR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75.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7 ± 1.1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3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ANT1ox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76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412.9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TC2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5.7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9 ± 0.4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HR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8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139.0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0 ± 1.1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838200" y="1305580"/>
            <a:ext cx="73914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1C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urple spot data collected in the experiment for assessment o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mpact of photoperiod on HDR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85800" y="5029200"/>
            <a:ext cx="970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 smtClean="0"/>
              <a:t>*</a:t>
            </a:r>
            <a:r>
              <a:rPr lang="en-US" baseline="30000" dirty="0" err="1" smtClean="0"/>
              <a:t>mean±SEM</a:t>
            </a:r>
            <a:endParaRPr lang="en-US" baseline="30000" dirty="0"/>
          </a:p>
        </p:txBody>
      </p:sp>
    </p:spTree>
    <p:extLst>
      <p:ext uri="{BB962C8B-B14F-4D97-AF65-F5344CB8AC3E}">
        <p14:creationId xmlns:p14="http://schemas.microsoft.com/office/powerpoint/2010/main" val="1660118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164068"/>
            <a:ext cx="8534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4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en-US" sz="14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2A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lANT1 locus mutation rates observed from transformed events of 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TC21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8338124"/>
              </p:ext>
            </p:extLst>
          </p:nvPr>
        </p:nvGraphicFramePr>
        <p:xfrm>
          <a:off x="1371600" y="685800"/>
          <a:ext cx="6477000" cy="525589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159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59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59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 smtClean="0">
                          <a:effectLst/>
                        </a:rPr>
                        <a:t>Transformed even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 err="1" smtClean="0">
                          <a:effectLst/>
                        </a:rPr>
                        <a:t>Indel</a:t>
                      </a:r>
                      <a:r>
                        <a:rPr lang="en-US" sz="1400" b="1" u="none" strike="noStrike" dirty="0" smtClean="0">
                          <a:effectLst/>
                        </a:rPr>
                        <a:t> mutation rate 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 smtClean="0">
                          <a:effectLst/>
                        </a:rPr>
                        <a:t>Knock-out rate 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4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4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5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5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4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1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ID9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29507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err="1" smtClean="0">
                          <a:effectLst/>
                        </a:rPr>
                        <a:t>Indel</a:t>
                      </a:r>
                      <a:r>
                        <a:rPr lang="en-US" sz="1400" kern="1200" baseline="0" dirty="0" smtClean="0">
                          <a:effectLst/>
                        </a:rPr>
                        <a:t> event </a:t>
                      </a:r>
                      <a:r>
                        <a:rPr lang="en-US" sz="1400" kern="1200" dirty="0" smtClean="0">
                          <a:effectLst/>
                        </a:rPr>
                        <a:t>rate</a:t>
                      </a:r>
                      <a:r>
                        <a:rPr lang="en-US" sz="1400" kern="1200" baseline="30000" dirty="0" smtClean="0">
                          <a:effectLst/>
                        </a:rPr>
                        <a:t>*</a:t>
                      </a:r>
                      <a:r>
                        <a:rPr lang="en-US" sz="1400" kern="1200" dirty="0" smtClean="0">
                          <a:effectLst/>
                        </a:rPr>
                        <a:t> /adjusted </a:t>
                      </a:r>
                      <a:r>
                        <a:rPr lang="en-US" sz="1400" kern="1200" dirty="0" err="1" smtClean="0">
                          <a:effectLst/>
                        </a:rPr>
                        <a:t>indel</a:t>
                      </a:r>
                      <a:r>
                        <a:rPr lang="en-US" sz="1400" kern="1200" dirty="0" smtClean="0">
                          <a:effectLst/>
                        </a:rPr>
                        <a:t> rate</a:t>
                      </a:r>
                      <a:r>
                        <a:rPr lang="en-US" sz="1400" kern="1200" baseline="30000" dirty="0" smtClean="0">
                          <a:effectLst/>
                        </a:rPr>
                        <a:t>**</a:t>
                      </a:r>
                      <a:endParaRPr lang="en-US" sz="14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 smtClean="0">
                          <a:effectLst/>
                        </a:rPr>
                        <a:t>60/17.6</a:t>
                      </a:r>
                      <a:endParaRPr lang="en-US" sz="140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u="none" strike="noStrike" kern="1200" dirty="0" smtClean="0">
                          <a:effectLst/>
                        </a:rPr>
                        <a:t>60/16.6</a:t>
                      </a:r>
                      <a:endParaRPr lang="en-US" sz="140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371600" y="6019800"/>
            <a:ext cx="60840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baseline="30000" dirty="0" smtClean="0"/>
              <a:t>*The </a:t>
            </a:r>
            <a:r>
              <a:rPr lang="en-US" i="1" baseline="30000" dirty="0" err="1" smtClean="0"/>
              <a:t>indel</a:t>
            </a:r>
            <a:r>
              <a:rPr lang="en-US" i="1" baseline="30000" dirty="0" smtClean="0"/>
              <a:t> event rate=total number events </a:t>
            </a:r>
            <a:r>
              <a:rPr lang="en-US" i="1" baseline="30000" dirty="0" smtClean="0"/>
              <a:t>carrying mutations/total </a:t>
            </a:r>
            <a:r>
              <a:rPr lang="en-US" i="1" baseline="30000" dirty="0" smtClean="0"/>
              <a:t>number of analyzed events</a:t>
            </a:r>
          </a:p>
          <a:p>
            <a:r>
              <a:rPr lang="en-US" i="1" baseline="30000" dirty="0" smtClean="0"/>
              <a:t>**The adjusted </a:t>
            </a:r>
            <a:r>
              <a:rPr lang="en-US" i="1" baseline="30000" dirty="0" err="1" smtClean="0"/>
              <a:t>indel</a:t>
            </a:r>
            <a:r>
              <a:rPr lang="en-US" i="1" baseline="30000" dirty="0" smtClean="0"/>
              <a:t> rate=sum of </a:t>
            </a:r>
            <a:r>
              <a:rPr lang="en-US" i="1" baseline="30000" dirty="0" err="1" smtClean="0"/>
              <a:t>indel</a:t>
            </a:r>
            <a:r>
              <a:rPr lang="en-US" i="1" baseline="30000" dirty="0" smtClean="0"/>
              <a:t> mutation rates/total number of analyzed events</a:t>
            </a:r>
            <a:endParaRPr lang="en-US" i="1" baseline="30000" dirty="0"/>
          </a:p>
        </p:txBody>
      </p:sp>
    </p:spTree>
    <p:extLst>
      <p:ext uri="{BB962C8B-B14F-4D97-AF65-F5344CB8AC3E}">
        <p14:creationId xmlns:p14="http://schemas.microsoft.com/office/powerpoint/2010/main" val="42733582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04800" y="76200"/>
            <a:ext cx="8534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4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en-US" sz="14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2B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Inde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 mutation rates observed from transformed pHR01 events at SlANT1 sites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3108162"/>
              </p:ext>
            </p:extLst>
          </p:nvPr>
        </p:nvGraphicFramePr>
        <p:xfrm>
          <a:off x="381000" y="381000"/>
          <a:ext cx="8458199" cy="6457374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55036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797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1797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1968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7649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75773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31797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255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formed even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tation rate (%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A1 </a:t>
                      </a:r>
                      <a:r>
                        <a:rPr lang="en-US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A2 </a:t>
                      </a:r>
                      <a:r>
                        <a:rPr lang="en-US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A1+gRNA2 </a:t>
                      </a:r>
                      <a:r>
                        <a:rPr lang="en-US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ock-out rate (%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3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3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3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1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463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2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3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2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  <a:endParaRPr lang="en-US" sz="12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  <a:endParaRPr lang="en-US" sz="12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  <a:endParaRPr lang="en-US" sz="12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3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2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  <a:endParaRPr lang="en-US" sz="12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  <a:endParaRPr lang="en-US" sz="12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  <a:endParaRPr lang="en-US" sz="12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3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12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  <a:endParaRPr lang="en-US" sz="12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  <a:endParaRPr lang="en-US" sz="12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2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</a:t>
                      </a:r>
                      <a:endParaRPr lang="en-US" sz="1200" b="1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365284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kern="12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200" b="1" kern="12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vent </a:t>
                      </a:r>
                      <a:r>
                        <a:rPr lang="en-US" sz="1200" b="1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e /adjusted </a:t>
                      </a:r>
                      <a:r>
                        <a:rPr lang="en-US" sz="1200" b="1" kern="12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l</a:t>
                      </a:r>
                      <a:r>
                        <a:rPr lang="en-US" sz="1200" b="1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at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6/5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6/53.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2/1.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3/2.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5/28.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29" marR="9429" marT="9429" marB="0" anchor="ctr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46020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0777163"/>
              </p:ext>
            </p:extLst>
          </p:nvPr>
        </p:nvGraphicFramePr>
        <p:xfrm>
          <a:off x="263525" y="1524000"/>
          <a:ext cx="8534400" cy="233529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617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9882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95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9845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No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Construct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Mean of HDR </a:t>
                      </a:r>
                      <a:r>
                        <a:rPr lang="en-US" sz="1600" b="1" u="none" strike="noStrike" dirty="0" smtClean="0">
                          <a:effectLst/>
                        </a:rPr>
                        <a:t>efficiency (%)</a:t>
                      </a:r>
                      <a:r>
                        <a:rPr lang="en-US" sz="1600" b="1" u="none" strike="noStrike" baseline="30000" dirty="0" smtClean="0">
                          <a:effectLst/>
                        </a:rPr>
                        <a:t>*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Standard error of the mean (SEM) (%)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Fold change compared to pHR0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Fold change compared to pMR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onor template peak at 3 day post-transformation</a:t>
                      </a: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008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pHR0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81</a:t>
                      </a:r>
                      <a:r>
                        <a:rPr lang="en-US" sz="16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8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9525" marR="9525" marT="952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008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 smtClean="0">
                          <a:effectLst/>
                        </a:rPr>
                        <a:t>MR0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82</a:t>
                      </a:r>
                      <a:r>
                        <a:rPr lang="en-US" sz="16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9525" marR="9525" marT="9522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008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 smtClean="0">
                          <a:effectLst/>
                        </a:rPr>
                        <a:t>MR0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79</a:t>
                      </a:r>
                      <a:r>
                        <a:rPr lang="en-US" sz="1600" b="1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7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.15</a:t>
                      </a:r>
                    </a:p>
                  </a:txBody>
                  <a:tcPr marL="9525" marR="9525" marT="9522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008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 smtClean="0">
                          <a:effectLst/>
                        </a:rPr>
                        <a:t>MR0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26</a:t>
                      </a:r>
                      <a:r>
                        <a:rPr lang="en-US" sz="16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b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6</a:t>
                      </a:r>
                    </a:p>
                  </a:txBody>
                  <a:tcPr marL="9525" marR="9525" marT="9522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008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5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 smtClean="0">
                          <a:effectLst/>
                        </a:rPr>
                        <a:t>MR0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3</a:t>
                      </a:r>
                      <a:r>
                        <a:rPr lang="en-US" sz="16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7</a:t>
                      </a:r>
                    </a:p>
                  </a:txBody>
                  <a:tcPr marL="9525" marR="9525" marT="9522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3" name="TextBox 5"/>
          <p:cNvSpPr txBox="1">
            <a:spLocks noChangeArrowheads="1"/>
          </p:cNvSpPr>
          <p:nvPr/>
        </p:nvSpPr>
        <p:spPr bwMode="auto">
          <a:xfrm>
            <a:off x="146050" y="3886200"/>
            <a:ext cx="634841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400" i="1" baseline="30000" dirty="0"/>
              <a:t>*</a:t>
            </a:r>
            <a:r>
              <a:rPr lang="en-US" altLang="en-US" sz="1400" i="1" dirty="0"/>
              <a:t>Value with the same alphabet letter is not significantly different (t-test, </a:t>
            </a:r>
            <a:r>
              <a:rPr lang="en-US" altLang="en-US" sz="1400" i="1" dirty="0" smtClean="0"/>
              <a:t>n=4, </a:t>
            </a:r>
            <a:r>
              <a:rPr lang="en-US" altLang="en-US" sz="1400" i="1" dirty="0"/>
              <a:t>p&lt;0.05)</a:t>
            </a:r>
            <a:endParaRPr lang="en-US" altLang="en-US" sz="1400" i="1" baseline="30000" dirty="0"/>
          </a:p>
        </p:txBody>
      </p:sp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381000" y="1160586"/>
            <a:ext cx="838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3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increase in HDR by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ulti-replico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ystems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40133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2258838"/>
              </p:ext>
            </p:extLst>
          </p:nvPr>
        </p:nvGraphicFramePr>
        <p:xfrm>
          <a:off x="381000" y="1203260"/>
          <a:ext cx="8458201" cy="4278007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4569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814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6842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797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’-3’)</a:t>
                      </a:r>
                      <a:endParaRPr lang="en-US" sz="14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 length (</a:t>
                      </a:r>
                      <a:r>
                        <a:rPr lang="en-US" sz="14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licon 1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0" lang="en-US" altLang="en-US" sz="140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itchFamily="34" charset="0"/>
                          <a:cs typeface="Arial" panose="020B0604020202020204" pitchFamily="34" charset="0"/>
                        </a:rPr>
                        <a:t>MR01</a:t>
                      </a:r>
                      <a:r>
                        <a:rPr lang="en-US" sz="140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400" i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1D2-cF1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AATTTCCCAATGTACCTATCC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0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f.ANT1-R4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TCAACGACGCAAGTATT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licon 2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0" lang="en-US" altLang="en-US" sz="140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itchFamily="34" charset="0"/>
                          <a:cs typeface="Arial" panose="020B0604020202020204" pitchFamily="34" charset="0"/>
                        </a:rPr>
                        <a:t>MR01</a:t>
                      </a:r>
                      <a:r>
                        <a:rPr lang="en-US" sz="140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400" i="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RA-R2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CAGTCCTCGTCAGGATTGC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3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S-R4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TCGAACTTCCTTCCTAGAT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licon 3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kumimoji="0" lang="en-US" altLang="en-US" sz="140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itchFamily="34" charset="0"/>
                          <a:cs typeface="Arial" panose="020B0604020202020204" pitchFamily="34" charset="0"/>
                        </a:rPr>
                        <a:t>MR01</a:t>
                      </a:r>
                      <a:r>
                        <a:rPr lang="en-US" sz="140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400" i="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RA-R2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CAGTCCTCGTCAGGATTGC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5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f.ANT1-R4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TCAACGACGCAAGTATT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R01 Replicon</a:t>
                      </a: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RA-R2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CAGTCCTCGTCAGGATTGC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8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f.ANT1-R4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TCAACGACGCAAGTATT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9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 </a:t>
                      </a:r>
                      <a:r>
                        <a:rPr lang="en-US" sz="18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Solyc05g014470.2)</a:t>
                      </a:r>
                      <a:endParaRPr lang="en-US" sz="1400" kern="12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GAPDH-F1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ATAACCTAATTTCTCTCT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1073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10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US" sz="1400" kern="12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GAPDH-R1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CATGAGACCCTCAACAAT</a:t>
                      </a:r>
                    </a:p>
                  </a:txBody>
                  <a:tcPr marL="68580" marR="68580" marT="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81000" y="838200"/>
            <a:ext cx="838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4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rimers for detecting circularized replicons released by MR01 and pHR01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86008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381000" y="1160585"/>
            <a:ext cx="838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5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T1 HDR events derived from thre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in HDR constructs used in the study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8807478"/>
              </p:ext>
            </p:extLst>
          </p:nvPr>
        </p:nvGraphicFramePr>
        <p:xfrm>
          <a:off x="990601" y="1676400"/>
          <a:ext cx="7543800" cy="17907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005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10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7522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43587">
                  <a:extLst>
                    <a:ext uri="{9D8B030D-6E8A-4147-A177-3AD203B41FA5}">
                      <a16:colId xmlns:a16="http://schemas.microsoft.com/office/drawing/2014/main" val="929733873"/>
                    </a:ext>
                  </a:extLst>
                </a:gridCol>
                <a:gridCol w="134358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6858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truct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</a:t>
                      </a:r>
                      <a:r>
                        <a:rPr lang="en-US" sz="14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tyledon explant 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  <a:r>
                        <a:rPr lang="en-US" sz="16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urple 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ot numbe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umber of purple plant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le spot formation rate (%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le plant formation rate 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524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C2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4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70</a:t>
                      </a:r>
                      <a:endParaRPr 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9.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147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R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4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4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04.7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0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7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03.5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048745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4385563"/>
              </p:ext>
            </p:extLst>
          </p:nvPr>
        </p:nvGraphicFramePr>
        <p:xfrm>
          <a:off x="381000" y="669860"/>
          <a:ext cx="8458201" cy="600020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4569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669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584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39602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797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’-3’)</a:t>
                      </a:r>
                      <a:endParaRPr lang="en-US" sz="14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 length (</a:t>
                      </a:r>
                      <a:r>
                        <a:rPr lang="en-US" sz="14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 junction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ANT1-F1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GATGATCTACGGTAACAA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5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TII-R1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GTGCAATCCATCTTGTTC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 junction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Y010F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GTAAGGGATGACGCACA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0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140R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CACCGGTCCATTCCCT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Full HDR allele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ANT1-F1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GATGATCTACGGTAACAA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4707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140R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CACCGGTCCATTCCCT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1 control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140F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AAATGGCATCTTGTTCCC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6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140R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CACCGGTCCATTCCCT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9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licon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-F1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AGATGAGCACTTGGGATAG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7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10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f.ANT1-R4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TCAACGACGCAAGTATT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11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T-DN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RB-qF2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CTTAGGTTTACCCGCCAATA</a:t>
                      </a:r>
                      <a:endParaRPr lang="en-US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961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12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RRA-R6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GTTCAGGTTGTGGAGGGAATA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13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RB</a:t>
                      </a: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-ANT1D2 integration at the left junction of ANT1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ANT1-F1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GATGATCTACGGTAACAA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2042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808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14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RRA-R6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algun Gothic"/>
                          <a:cs typeface="Arial" panose="020B0604020202020204" pitchFamily="34" charset="0"/>
                        </a:rPr>
                        <a:t>GTTCAGGTTGTGGAGGGAATA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381000" y="304800"/>
            <a:ext cx="6411686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en-US" sz="14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6</a:t>
            </a: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. </a:t>
            </a:r>
            <a:r>
              <a:rPr kumimoji="0" lang="en-US" altLang="en-US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Primers for LbCpf1-based HR event analyses 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26740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228600" y="1082189"/>
            <a:ext cx="6411686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Table 7. </a:t>
            </a:r>
            <a:r>
              <a:rPr lang="en-US" altLang="en-US" sz="1400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Primer</a:t>
            </a:r>
            <a:r>
              <a:rPr kumimoji="0" lang="en-US" altLang="en-US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 for SpCas9-based HR event analyses </a:t>
            </a:r>
            <a:endParaRPr kumimoji="0" lang="en-US" altLang="en-US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5380067"/>
              </p:ext>
            </p:extLst>
          </p:nvPr>
        </p:nvGraphicFramePr>
        <p:xfrm>
          <a:off x="304800" y="1450780"/>
          <a:ext cx="8458200" cy="337972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4569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6698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584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39602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797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637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</a:t>
                      </a:r>
                      <a:endParaRPr lang="en-US" sz="14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’-3’)</a:t>
                      </a:r>
                      <a:endParaRPr lang="en-US" sz="1400" b="1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 length (</a:t>
                      </a:r>
                      <a:r>
                        <a:rPr lang="en-US" sz="14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37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 junction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ANT1-F1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GATGATCTACGGTAACAAA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5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637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TII-R1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GTGCAATCCATCTTGTTC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637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 junction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Y010F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GTAAGGGATGACGCACA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0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637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140R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CACCGGTCCATTCCCT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637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1 control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140F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AAATGGCATCTTGTTCCC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6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637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140R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CACCGGTCCATTCCCT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637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licon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-F1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AGATGAGCACTTGGGATAG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98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637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S-R3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CAGTGGAGATGTCACATCA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algun Gothic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88802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59</TotalTime>
  <Words>1382</Words>
  <Application>Microsoft Office PowerPoint</Application>
  <PresentationFormat>화면 슬라이드 쇼(4:3)</PresentationFormat>
  <Paragraphs>902</Paragraphs>
  <Slides>1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2</vt:i4>
      </vt:variant>
    </vt:vector>
  </HeadingPairs>
  <TitlesOfParts>
    <vt:vector size="17" baseType="lpstr">
      <vt:lpstr>Malgun Gothic</vt:lpstr>
      <vt:lpstr>Malgun Gothic</vt:lpstr>
      <vt:lpstr>Arial</vt:lpstr>
      <vt:lpstr>Calibri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USER</cp:lastModifiedBy>
  <cp:revision>744</cp:revision>
  <cp:lastPrinted>2019-11-30T02:57:49Z</cp:lastPrinted>
  <dcterms:created xsi:type="dcterms:W3CDTF">2018-09-26T13:43:48Z</dcterms:created>
  <dcterms:modified xsi:type="dcterms:W3CDTF">2019-12-24T05:34:31Z</dcterms:modified>
</cp:coreProperties>
</file>